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3" d="100"/>
          <a:sy n="73" d="100"/>
        </p:scale>
        <p:origin x="-948" y="153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792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770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943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189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858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173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259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032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441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769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058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242D3-D5CD-4D7C-9E6F-748CF1641723}" type="datetimeFigureOut">
              <a:rPr lang="en-US" smtClean="0"/>
              <a:t>7/8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1B5547-5ECA-44C6-B44E-0C8BFE59FA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08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79400" y="6804248"/>
            <a:ext cx="637270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crosatellite assessment by polymerase chain reaction (MSI-PCR of 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e two tumor blocks used for MMR-IHC were consistently assessed as microsatellite stable (MSS) 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-B).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SI-PCR of six mononucleotide microsatellite markers including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R21, Bat26, Bat25, NR27, NR24, and Mono27, two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ntanucleotid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microsatellite markers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ntaC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nta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and an internal control,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eI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Microsatellite instability with MSI-PCR is assessed as low (MSI-L) if having 1 marker exhibiting changes in length, and assessed as high (MSI-H) when having 2 or more markers exhibiting increase or decrease in length of microsatellite markers. MSS is assessed when all markers have no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change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272" y="386972"/>
            <a:ext cx="4320000" cy="30329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45094" y="30567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3703" y="3710333"/>
            <a:ext cx="4320000" cy="3028454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821525" y="35638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7087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1990" y="3747323"/>
            <a:ext cx="4967912" cy="305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72249" y="30567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48680" y="367531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36955" y="7020272"/>
            <a:ext cx="544903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Detection of 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germline homozygous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MSH6 missense mutation in the patient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. Illustration of the homozygous germlin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MSH6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.3226C&gt;T (p.R1076C) 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patient using the Integrated Genome Viewer. B. Pedigree analysis illustrating the family history of cancer and the detection of homozygous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MSH6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R1076C mutation in the patient (III.1) and heterozygous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MSH6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R1076C mutation in the parents of the patient (II.1 and II.2), his wife (III.2) and his two daughters (IV.1 an IV.2).</a:t>
            </a:r>
          </a:p>
          <a:p>
            <a:pPr algn="just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75" r="26219" b="8571"/>
          <a:stretch/>
        </p:blipFill>
        <p:spPr>
          <a:xfrm>
            <a:off x="1052736" y="395536"/>
            <a:ext cx="3477974" cy="3217270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773701" y="3482718"/>
            <a:ext cx="511283" cy="1692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2635277" y="3427660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SH6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0844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213</Words>
  <Application>Microsoft Office PowerPoint</Application>
  <PresentationFormat>全屏显示(4:3)</PresentationFormat>
  <Paragraphs>7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​​</vt:lpstr>
      <vt:lpstr>PowerPoint 演示文稿</vt:lpstr>
      <vt:lpstr>PowerPoint 演示文稿</vt:lpstr>
    </vt:vector>
  </TitlesOfParts>
  <Company>SCCM-CAS-S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饶安丽</dc:creator>
  <cp:lastModifiedBy>饶安丽</cp:lastModifiedBy>
  <cp:revision>31</cp:revision>
  <dcterms:created xsi:type="dcterms:W3CDTF">2019-11-12T07:44:35Z</dcterms:created>
  <dcterms:modified xsi:type="dcterms:W3CDTF">2020-07-08T03:07:55Z</dcterms:modified>
</cp:coreProperties>
</file>